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3" r:id="rId3"/>
  </p:sldIdLst>
  <p:sldSz cx="9144000" cy="6858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5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70519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51633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1414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48004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04358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56912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11659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85920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32165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1868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83321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26CD4-0FBC-4B4B-9FFA-E029B00A4749}" type="datetimeFigureOut">
              <a:rPr lang="th-TH" smtClean="0"/>
              <a:t>20/05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C9284-B7B9-49C5-9F85-E725D98BED40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36948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5A0CCBBB-A83F-F845-B716-AB27A4EAA2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7315642"/>
              </p:ext>
            </p:extLst>
          </p:nvPr>
        </p:nvGraphicFramePr>
        <p:xfrm>
          <a:off x="122663" y="526384"/>
          <a:ext cx="8798314" cy="57728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5898">
                  <a:extLst>
                    <a:ext uri="{9D8B030D-6E8A-4147-A177-3AD203B41FA5}">
                      <a16:colId xmlns:a16="http://schemas.microsoft.com/office/drawing/2014/main" val="609438888"/>
                    </a:ext>
                  </a:extLst>
                </a:gridCol>
                <a:gridCol w="2165722">
                  <a:extLst>
                    <a:ext uri="{9D8B030D-6E8A-4147-A177-3AD203B41FA5}">
                      <a16:colId xmlns:a16="http://schemas.microsoft.com/office/drawing/2014/main" val="1406580611"/>
                    </a:ext>
                  </a:extLst>
                </a:gridCol>
                <a:gridCol w="1681546">
                  <a:extLst>
                    <a:ext uri="{9D8B030D-6E8A-4147-A177-3AD203B41FA5}">
                      <a16:colId xmlns:a16="http://schemas.microsoft.com/office/drawing/2014/main" val="2453805695"/>
                    </a:ext>
                  </a:extLst>
                </a:gridCol>
                <a:gridCol w="2097574">
                  <a:extLst>
                    <a:ext uri="{9D8B030D-6E8A-4147-A177-3AD203B41FA5}">
                      <a16:colId xmlns:a16="http://schemas.microsoft.com/office/drawing/2014/main" val="1161240813"/>
                    </a:ext>
                  </a:extLst>
                </a:gridCol>
                <a:gridCol w="2097574">
                  <a:extLst>
                    <a:ext uri="{9D8B030D-6E8A-4147-A177-3AD203B41FA5}">
                      <a16:colId xmlns:a16="http://schemas.microsoft.com/office/drawing/2014/main" val="1147715367"/>
                    </a:ext>
                  </a:extLst>
                </a:gridCol>
              </a:tblGrid>
              <a:tr h="502604">
                <a:tc>
                  <a:txBody>
                    <a:bodyPr/>
                    <a:lstStyle/>
                    <a:p>
                      <a:pPr algn="ctr"/>
                      <a:r>
                        <a:rPr lang="en-TH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TH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ginal SDS PA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S-PAGE in manuscrip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TH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ginal Western blo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stern blot in manuscrip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3488990"/>
                  </a:ext>
                </a:extLst>
              </a:tr>
              <a:tr h="1414168">
                <a:tc>
                  <a:txBody>
                    <a:bodyPr/>
                    <a:lstStyle/>
                    <a:p>
                      <a:r>
                        <a:rPr lang="en-US" sz="12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xIIPF</a:t>
                      </a:r>
                      <a:endParaRPr lang="en-TH" sz="12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1811091"/>
                  </a:ext>
                </a:extLst>
              </a:tr>
              <a:tr h="1414168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iC</a:t>
                      </a:r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9989370"/>
                  </a:ext>
                </a:extLst>
              </a:tr>
              <a:tr h="1414168">
                <a:tc>
                  <a:txBody>
                    <a:bodyPr/>
                    <a:lstStyle/>
                    <a:p>
                      <a:r>
                        <a:rPr lang="en-TH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xIIPF-</a:t>
                      </a:r>
                      <a:r>
                        <a:rPr lang="en-TH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TH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iC</a:t>
                      </a:r>
                    </a:p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th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th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th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th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th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TH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0849601"/>
                  </a:ext>
                </a:extLst>
              </a:tr>
            </a:tbl>
          </a:graphicData>
        </a:graphic>
      </p:graphicFrame>
      <p:pic>
        <p:nvPicPr>
          <p:cNvPr id="17" name="Picture 16">
            <a:extLst>
              <a:ext uri="{FF2B5EF4-FFF2-40B4-BE49-F238E27FC236}">
                <a16:creationId xmlns:a16="http://schemas.microsoft.com/office/drawing/2014/main" id="{222526F4-1644-1141-A61E-A2BFCF4B83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44" t="14883" r="33188" b="24928"/>
          <a:stretch/>
        </p:blipFill>
        <p:spPr>
          <a:xfrm>
            <a:off x="5198195" y="2687371"/>
            <a:ext cx="1420195" cy="1641149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D1020116-0A3A-3547-9B48-0CDF242D9E54}"/>
              </a:ext>
            </a:extLst>
          </p:cNvPr>
          <p:cNvGrpSpPr/>
          <p:nvPr/>
        </p:nvGrpSpPr>
        <p:grpSpPr>
          <a:xfrm>
            <a:off x="1270396" y="4657339"/>
            <a:ext cx="1480415" cy="1615827"/>
            <a:chOff x="1490760" y="5043879"/>
            <a:chExt cx="1272500" cy="1255581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75F380FB-E1DC-A04E-8F49-8BF81BCD8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90760" y="5056685"/>
              <a:ext cx="1064111" cy="116545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3A0AD89-ED5F-1746-A24B-A1556AD6AFDC}"/>
                </a:ext>
              </a:extLst>
            </p:cNvPr>
            <p:cNvSpPr txBox="1"/>
            <p:nvPr/>
          </p:nvSpPr>
          <p:spPr>
            <a:xfrm>
              <a:off x="2496117" y="5043879"/>
              <a:ext cx="267143" cy="12555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75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63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48</a:t>
              </a:r>
            </a:p>
            <a:p>
              <a:endParaRPr lang="en-TH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5</a:t>
              </a:r>
            </a:p>
            <a:p>
              <a:endParaRPr lang="en-TH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TH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5</a:t>
              </a:r>
            </a:p>
            <a:p>
              <a:endParaRPr lang="en-TH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7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1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1A0A1742-46B6-CE42-93E9-A44B79DB2F07}"/>
              </a:ext>
            </a:extLst>
          </p:cNvPr>
          <p:cNvSpPr txBox="1"/>
          <p:nvPr/>
        </p:nvSpPr>
        <p:spPr>
          <a:xfrm>
            <a:off x="4960484" y="2622371"/>
            <a:ext cx="354584" cy="13696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  <a:p>
            <a:endParaRPr lang="en-TH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  <a:p>
            <a:endParaRPr lang="en-TH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  <a:p>
            <a:endParaRPr lang="en-TH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TH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253D6F2-95BE-3E40-9CD4-D01FF749CD72}"/>
              </a:ext>
            </a:extLst>
          </p:cNvPr>
          <p:cNvSpPr txBox="1"/>
          <p:nvPr/>
        </p:nvSpPr>
        <p:spPr>
          <a:xfrm>
            <a:off x="2566143" y="123650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pic>
        <p:nvPicPr>
          <p:cNvPr id="30" name="Picture 29" descr="A picture containing text, beverage, drinking water&#10;&#10;Description automatically generated">
            <a:extLst>
              <a:ext uri="{FF2B5EF4-FFF2-40B4-BE49-F238E27FC236}">
                <a16:creationId xmlns:a16="http://schemas.microsoft.com/office/drawing/2014/main" id="{24B8CAC6-C86F-7544-86DE-2382BE47C15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6838" y="2787017"/>
            <a:ext cx="1273647" cy="140911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C9BE9235-F5C3-E649-B2C1-89C9B9FE6E9A}"/>
              </a:ext>
            </a:extLst>
          </p:cNvPr>
          <p:cNvSpPr txBox="1"/>
          <p:nvPr/>
        </p:nvSpPr>
        <p:spPr>
          <a:xfrm>
            <a:off x="2549325" y="112193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814DED5E-11B2-8943-AA3F-A73A2BBA0A16}"/>
              </a:ext>
            </a:extLst>
          </p:cNvPr>
          <p:cNvGrpSpPr/>
          <p:nvPr/>
        </p:nvGrpSpPr>
        <p:grpSpPr>
          <a:xfrm>
            <a:off x="1176838" y="993661"/>
            <a:ext cx="1683912" cy="1393256"/>
            <a:chOff x="2639108" y="995802"/>
            <a:chExt cx="1683912" cy="139325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34AC75E-8856-EE45-8E39-21BCBDDAEBAA}"/>
                </a:ext>
              </a:extLst>
            </p:cNvPr>
            <p:cNvGrpSpPr/>
            <p:nvPr/>
          </p:nvGrpSpPr>
          <p:grpSpPr>
            <a:xfrm>
              <a:off x="2639108" y="1139034"/>
              <a:ext cx="1656243" cy="1250024"/>
              <a:chOff x="2619081" y="1287513"/>
              <a:chExt cx="1656243" cy="125002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5F9DF406-734A-C24A-8F43-074EE9A85C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619081" y="1287513"/>
                <a:ext cx="1450411" cy="1250024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8FF7694-5A5C-934C-974A-63EFA8014980}"/>
                  </a:ext>
                </a:extLst>
              </p:cNvPr>
              <p:cNvSpPr txBox="1"/>
              <p:nvPr/>
            </p:nvSpPr>
            <p:spPr>
              <a:xfrm>
                <a:off x="4000890" y="1333574"/>
                <a:ext cx="274434" cy="10772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  <a:p>
                <a:endParaRPr lang="en-TH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  <a:p>
                <a:endParaRPr lang="en-TH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  <a:p>
                <a:r>
                  <a:rPr lang="en-TH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</a:t>
                </a:r>
              </a:p>
              <a:p>
                <a:endParaRPr lang="en-TH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4451D699-5807-5A41-8CC4-C5F49E463EF0}"/>
                  </a:ext>
                </a:extLst>
              </p:cNvPr>
              <p:cNvCxnSpPr/>
              <p:nvPr/>
            </p:nvCxnSpPr>
            <p:spPr>
              <a:xfrm>
                <a:off x="3626776" y="1330991"/>
                <a:ext cx="0" cy="199859"/>
              </a:xfrm>
              <a:prstGeom prst="straightConnector1">
                <a:avLst/>
              </a:prstGeom>
              <a:ln w="9525">
                <a:solidFill>
                  <a:srgbClr val="C00000"/>
                </a:solidFill>
                <a:tailEnd type="triangle"/>
              </a:ln>
            </p:spPr>
            <p:style>
              <a:lnRef idx="2">
                <a:schemeClr val="accent2"/>
              </a:lnRef>
              <a:fillRef idx="0">
                <a:schemeClr val="accent2"/>
              </a:fillRef>
              <a:effectRef idx="1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AEF9064-1193-C94E-973E-09C5D3ACE758}"/>
                </a:ext>
              </a:extLst>
            </p:cNvPr>
            <p:cNvSpPr txBox="1"/>
            <p:nvPr/>
          </p:nvSpPr>
          <p:spPr>
            <a:xfrm>
              <a:off x="4010114" y="1182252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7B4F0B6-75B3-7947-B306-64E2B3517B83}"/>
                </a:ext>
              </a:extLst>
            </p:cNvPr>
            <p:cNvSpPr txBox="1"/>
            <p:nvPr/>
          </p:nvSpPr>
          <p:spPr>
            <a:xfrm>
              <a:off x="4010114" y="995802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  <a:p>
              <a:r>
                <a:rPr lang="en-TH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B5B4ECD8-D8CB-1F4C-9706-CB7ADE9D3C0C}"/>
              </a:ext>
            </a:extLst>
          </p:cNvPr>
          <p:cNvSpPr txBox="1"/>
          <p:nvPr/>
        </p:nvSpPr>
        <p:spPr>
          <a:xfrm>
            <a:off x="2367141" y="284039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FC3E2B6-227D-CE46-A712-ACF3EDD41B9E}"/>
              </a:ext>
            </a:extLst>
          </p:cNvPr>
          <p:cNvSpPr txBox="1"/>
          <p:nvPr/>
        </p:nvSpPr>
        <p:spPr>
          <a:xfrm>
            <a:off x="2367141" y="276911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F69AFCAA-6D71-C74C-84B6-D309B6E0F79E}"/>
              </a:ext>
            </a:extLst>
          </p:cNvPr>
          <p:cNvGrpSpPr/>
          <p:nvPr/>
        </p:nvGrpSpPr>
        <p:grpSpPr>
          <a:xfrm>
            <a:off x="2363202" y="2603901"/>
            <a:ext cx="396668" cy="1567492"/>
            <a:chOff x="3901078" y="2471944"/>
            <a:chExt cx="396668" cy="1567492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85FAF4F-40C8-BC43-9D87-0BBCBDC497E3}"/>
                </a:ext>
              </a:extLst>
            </p:cNvPr>
            <p:cNvSpPr txBox="1"/>
            <p:nvPr/>
          </p:nvSpPr>
          <p:spPr>
            <a:xfrm>
              <a:off x="3943161" y="2639053"/>
              <a:ext cx="354585" cy="1400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TH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</a:t>
              </a: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  <a:p>
              <a:endParaRPr lang="en-TH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  <a:p>
              <a:endParaRPr lang="en-TH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  <a:p>
              <a:endParaRPr lang="en-TH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  <a:p>
              <a:endParaRPr lang="en-TH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TH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9C74474-3B70-8245-9FCE-E61A922C4D21}"/>
                </a:ext>
              </a:extLst>
            </p:cNvPr>
            <p:cNvSpPr txBox="1"/>
            <p:nvPr/>
          </p:nvSpPr>
          <p:spPr>
            <a:xfrm>
              <a:off x="3901078" y="2471944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C28C63EC-41E0-9247-83CC-C8E4C87E6A59}"/>
              </a:ext>
            </a:extLst>
          </p:cNvPr>
          <p:cNvSpPr txBox="1"/>
          <p:nvPr/>
        </p:nvSpPr>
        <p:spPr>
          <a:xfrm>
            <a:off x="2435493" y="4518839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</a:p>
          <a:p>
            <a:r>
              <a:rPr lang="en-TH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5AA58F9-67ED-4B42-A4FC-42925C5FDD19}"/>
              </a:ext>
            </a:extLst>
          </p:cNvPr>
          <p:cNvSpPr txBox="1"/>
          <p:nvPr/>
        </p:nvSpPr>
        <p:spPr>
          <a:xfrm>
            <a:off x="8962886" y="1803928"/>
            <a:ext cx="248786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  <a:p>
            <a:endParaRPr lang="en-TH" sz="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  <a:p>
            <a:endParaRPr lang="en-TH" sz="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32A710-DD78-8848-87B4-BE7B95BB1D5B}"/>
              </a:ext>
            </a:extLst>
          </p:cNvPr>
          <p:cNvSpPr txBox="1"/>
          <p:nvPr/>
        </p:nvSpPr>
        <p:spPr>
          <a:xfrm>
            <a:off x="7643278" y="1336528"/>
            <a:ext cx="28084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E4A17A3A-3271-FD4F-9F6A-E12EB2D19DF0}"/>
              </a:ext>
            </a:extLst>
          </p:cNvPr>
          <p:cNvGrpSpPr/>
          <p:nvPr/>
        </p:nvGrpSpPr>
        <p:grpSpPr>
          <a:xfrm>
            <a:off x="4865806" y="4594151"/>
            <a:ext cx="1874480" cy="1659178"/>
            <a:chOff x="4855437" y="4604191"/>
            <a:chExt cx="1874480" cy="1659178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3E70967A-A1FD-2E4D-89C3-96D75A2E2D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8617" t="16611" r="21532" b="24467"/>
            <a:stretch/>
          </p:blipFill>
          <p:spPr>
            <a:xfrm>
              <a:off x="4855437" y="4819173"/>
              <a:ext cx="1874480" cy="1369606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FB46AEF-1A4F-3044-BAC6-34B75E6D14B2}"/>
                </a:ext>
              </a:extLst>
            </p:cNvPr>
            <p:cNvSpPr txBox="1"/>
            <p:nvPr/>
          </p:nvSpPr>
          <p:spPr>
            <a:xfrm>
              <a:off x="5708557" y="4724486"/>
              <a:ext cx="319318" cy="1538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80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35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00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75</a:t>
              </a:r>
              <a:endParaRPr lang="en-US" sz="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63</a:t>
              </a:r>
            </a:p>
            <a:p>
              <a:endParaRPr 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48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35</a:t>
              </a:r>
            </a:p>
            <a:p>
              <a:endParaRPr 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25</a:t>
              </a:r>
            </a:p>
            <a:p>
              <a:endParaRPr 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17</a:t>
              </a:r>
            </a:p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11</a:t>
              </a:r>
              <a:endParaRPr lang="en-TH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8D17800D-AA29-DF4E-95A5-48B1864EC930}"/>
                </a:ext>
              </a:extLst>
            </p:cNvPr>
            <p:cNvCxnSpPr/>
            <p:nvPr/>
          </p:nvCxnSpPr>
          <p:spPr>
            <a:xfrm>
              <a:off x="6165947" y="4852626"/>
              <a:ext cx="0" cy="193337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C781325-F50A-5D4B-99B0-E9EFD7085FCD}"/>
                </a:ext>
              </a:extLst>
            </p:cNvPr>
            <p:cNvSpPr txBox="1"/>
            <p:nvPr/>
          </p:nvSpPr>
          <p:spPr>
            <a:xfrm>
              <a:off x="5701343" y="4604191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</p:txBody>
        </p:sp>
      </p:grpSp>
      <p:pic>
        <p:nvPicPr>
          <p:cNvPr id="50" name="Picture 49">
            <a:extLst>
              <a:ext uri="{FF2B5EF4-FFF2-40B4-BE49-F238E27FC236}">
                <a16:creationId xmlns:a16="http://schemas.microsoft.com/office/drawing/2014/main" id="{002FF731-3353-8B4D-8975-EDB42E3180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80136" y="1121937"/>
            <a:ext cx="308510" cy="1305235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7A66A398-4550-0E49-A429-22EA6FBD714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57162" y="2648342"/>
            <a:ext cx="354585" cy="1500167"/>
          </a:xfrm>
          <a:prstGeom prst="rect">
            <a:avLst/>
          </a:prstGeom>
        </p:spPr>
      </p:pic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41B9772-404A-4A40-8F9C-0DB4D5142CF1}"/>
              </a:ext>
            </a:extLst>
          </p:cNvPr>
          <p:cNvCxnSpPr/>
          <p:nvPr/>
        </p:nvCxnSpPr>
        <p:spPr>
          <a:xfrm>
            <a:off x="2106244" y="3178950"/>
            <a:ext cx="0" cy="2500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9A0FED29-3535-BD41-BA94-56E1CA10FE2E}"/>
              </a:ext>
            </a:extLst>
          </p:cNvPr>
          <p:cNvCxnSpPr/>
          <p:nvPr/>
        </p:nvCxnSpPr>
        <p:spPr>
          <a:xfrm>
            <a:off x="1444605" y="4559083"/>
            <a:ext cx="0" cy="25005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Picture 54">
            <a:extLst>
              <a:ext uri="{FF2B5EF4-FFF2-40B4-BE49-F238E27FC236}">
                <a16:creationId xmlns:a16="http://schemas.microsoft.com/office/drawing/2014/main" id="{3A35B76F-BBB3-424F-B18B-66B73950D2D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26060" y="4549130"/>
            <a:ext cx="366213" cy="1615827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659A3DCB-0C50-7044-9AFA-ECE835F9258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78604" y="1107612"/>
            <a:ext cx="324565" cy="1266569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E8C76F15-7AF5-3540-BE9E-1C580294DA2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559352" y="2553326"/>
            <a:ext cx="333746" cy="1618067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8488F064-B49F-744C-B42A-73668791567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515701" y="4657339"/>
            <a:ext cx="335784" cy="154621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D2AAF10-1D9F-6040-8428-376A58FE4131}"/>
              </a:ext>
            </a:extLst>
          </p:cNvPr>
          <p:cNvSpPr txBox="1"/>
          <p:nvPr/>
        </p:nvSpPr>
        <p:spPr>
          <a:xfrm>
            <a:off x="6589725" y="1046900"/>
            <a:ext cx="1040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per membrane edges</a:t>
            </a:r>
            <a:endParaRPr lang="en-TH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 descr="A close-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AE932030-E372-7C41-98EF-1994DD653926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13" t="14854" r="1583"/>
          <a:stretch/>
        </p:blipFill>
        <p:spPr>
          <a:xfrm>
            <a:off x="4884021" y="1079397"/>
            <a:ext cx="1746630" cy="1322997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09E50AB6-964F-C241-8736-9C0DA3ED89AA}"/>
              </a:ext>
            </a:extLst>
          </p:cNvPr>
          <p:cNvSpPr txBox="1"/>
          <p:nvPr/>
        </p:nvSpPr>
        <p:spPr>
          <a:xfrm>
            <a:off x="6263851" y="4634515"/>
            <a:ext cx="1040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per membrane edges</a:t>
            </a:r>
            <a:endParaRPr lang="en-TH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9D3180E-1F2C-7840-8EC6-EFCD33FBE381}"/>
              </a:ext>
            </a:extLst>
          </p:cNvPr>
          <p:cNvSpPr txBox="1"/>
          <p:nvPr/>
        </p:nvSpPr>
        <p:spPr>
          <a:xfrm>
            <a:off x="5720307" y="1174945"/>
            <a:ext cx="2808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DACCFBA-3836-7D40-827E-31C402D9725D}"/>
              </a:ext>
            </a:extLst>
          </p:cNvPr>
          <p:cNvSpPr txBox="1"/>
          <p:nvPr/>
        </p:nvSpPr>
        <p:spPr>
          <a:xfrm>
            <a:off x="5719489" y="1120653"/>
            <a:ext cx="29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CB309E9-1E42-964C-9B13-4230384B0E67}"/>
              </a:ext>
            </a:extLst>
          </p:cNvPr>
          <p:cNvSpPr txBox="1"/>
          <p:nvPr/>
        </p:nvSpPr>
        <p:spPr>
          <a:xfrm>
            <a:off x="5753872" y="1340085"/>
            <a:ext cx="2487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8CA53452-7A40-E24D-95BF-1E10C886BC1A}"/>
              </a:ext>
            </a:extLst>
          </p:cNvPr>
          <p:cNvCxnSpPr/>
          <p:nvPr/>
        </p:nvCxnSpPr>
        <p:spPr>
          <a:xfrm>
            <a:off x="6067760" y="1242580"/>
            <a:ext cx="0" cy="172507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FAE4D4F-15D1-BF41-A42F-DCA5E4FE37AA}"/>
              </a:ext>
            </a:extLst>
          </p:cNvPr>
          <p:cNvSpPr txBox="1"/>
          <p:nvPr/>
        </p:nvSpPr>
        <p:spPr>
          <a:xfrm>
            <a:off x="5727700" y="1282235"/>
            <a:ext cx="28084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11EB273-6234-8240-A0B4-5DF876B0F987}"/>
              </a:ext>
            </a:extLst>
          </p:cNvPr>
          <p:cNvSpPr txBox="1"/>
          <p:nvPr/>
        </p:nvSpPr>
        <p:spPr>
          <a:xfrm>
            <a:off x="5750862" y="1380230"/>
            <a:ext cx="248786" cy="1046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  <a:p>
            <a:endParaRPr lang="en-TH" sz="7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TH" sz="5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  <a:p>
            <a:endParaRPr lang="en-TH" sz="5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9651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48D6363-4D86-3544-B4E0-45D308802485}"/>
              </a:ext>
            </a:extLst>
          </p:cNvPr>
          <p:cNvSpPr/>
          <p:nvPr/>
        </p:nvSpPr>
        <p:spPr>
          <a:xfrm>
            <a:off x="721360" y="1290683"/>
            <a:ext cx="7853680" cy="77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PMingLiU" panose="02020500000000000000" pitchFamily="18" charset="-120"/>
                <a:cs typeface="Cordia New" panose="020B0304020202020204" pitchFamily="34" charset="-34"/>
              </a:rPr>
              <a:t>Supplementary Figure 1</a:t>
            </a:r>
            <a:r>
              <a:rPr lang="th-TH" sz="1200" dirty="0">
                <a:solidFill>
                  <a:srgbClr val="000000"/>
                </a:solidFill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PMingLiU" panose="02020500000000000000" pitchFamily="18" charset="-120"/>
                <a:cs typeface="Cordia New" panose="020B0304020202020204" pitchFamily="34" charset="-34"/>
              </a:rPr>
              <a:t>Original files of SDS-PAGE and Western blots of purified recombinant proteins. SDS-PAGE and Western blot analysis were performed to verify recombinant protein production and identity. </a:t>
            </a:r>
          </a:p>
        </p:txBody>
      </p:sp>
    </p:spTree>
    <p:extLst>
      <p:ext uri="{BB962C8B-B14F-4D97-AF65-F5344CB8AC3E}">
        <p14:creationId xmlns:p14="http://schemas.microsoft.com/office/powerpoint/2010/main" val="601445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92</TotalTime>
  <Words>144</Words>
  <Application>Microsoft Macintosh PowerPoint</Application>
  <PresentationFormat>On-screen Show (4:3)</PresentationFormat>
  <Paragraphs>1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PUST</dc:creator>
  <cp:lastModifiedBy>Kamonpun Chuekwon</cp:lastModifiedBy>
  <cp:revision>131</cp:revision>
  <dcterms:created xsi:type="dcterms:W3CDTF">2021-06-21T09:34:20Z</dcterms:created>
  <dcterms:modified xsi:type="dcterms:W3CDTF">2022-05-20T15:24:26Z</dcterms:modified>
</cp:coreProperties>
</file>